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91" d="100"/>
          <a:sy n="91" d="100"/>
        </p:scale>
        <p:origin x="343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ja-JP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2790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6662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58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1627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51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806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340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6215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6868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055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ja-JP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6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3D76F-3B20-1A47-8EFF-4F9E6CB8933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8EB3D-581A-1E40-9CE5-E6F916A6FB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393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1A5F48A-33FC-F540-9B9F-B310FABF2740}"/>
              </a:ext>
            </a:extLst>
          </p:cNvPr>
          <p:cNvSpPr txBox="1"/>
          <p:nvPr/>
        </p:nvSpPr>
        <p:spPr>
          <a:xfrm>
            <a:off x="147483" y="1784555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6">
            <a:extLst>
              <a:ext uri="{FF2B5EF4-FFF2-40B4-BE49-F238E27FC236}">
                <a16:creationId xmlns:a16="http://schemas.microsoft.com/office/drawing/2014/main" id="{2DFF1A73-E201-F84C-9D8B-C912D0E8B1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7886" y="2539742"/>
            <a:ext cx="4572000" cy="4572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7B5F005-6FF5-394E-AEB6-1F5E9F2FDEE2}"/>
              </a:ext>
            </a:extLst>
          </p:cNvPr>
          <p:cNvSpPr txBox="1"/>
          <p:nvPr/>
        </p:nvSpPr>
        <p:spPr>
          <a:xfrm>
            <a:off x="1991563" y="6628516"/>
            <a:ext cx="282160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ale strobilus area (mm</a:t>
            </a:r>
            <a:r>
              <a:rPr kumimoji="1"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574FEE3-F3A0-9043-AFCE-6A3EAEFB1AF1}"/>
              </a:ext>
            </a:extLst>
          </p:cNvPr>
          <p:cNvSpPr/>
          <p:nvPr/>
        </p:nvSpPr>
        <p:spPr>
          <a:xfrm>
            <a:off x="-1331043" y="7197774"/>
            <a:ext cx="7835082" cy="618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Aft>
                <a:spcPts val="3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catterplot of male strobilus weight and area.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l samples are shown in this figure. Weight and area are strongly correlated (r = 0.892). Different clones are represented by different symbols (see Table 1).</a:t>
            </a:r>
            <a:endParaRPr lang="en-JP" sz="1200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5197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yuki KAKUI</dc:creator>
  <cp:lastModifiedBy>Hiroyuki KAKUI</cp:lastModifiedBy>
  <cp:revision>1</cp:revision>
  <dcterms:created xsi:type="dcterms:W3CDTF">2021-04-14T01:55:02Z</dcterms:created>
  <dcterms:modified xsi:type="dcterms:W3CDTF">2021-04-14T01:55:47Z</dcterms:modified>
</cp:coreProperties>
</file>